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  <p:sldId id="261" r:id="rId3"/>
    <p:sldId id="262" r:id="rId4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132" autoAdjust="0"/>
    <p:restoredTop sz="94695"/>
  </p:normalViewPr>
  <p:slideViewPr>
    <p:cSldViewPr snapToGrid="0" snapToObjects="1">
      <p:cViewPr>
        <p:scale>
          <a:sx n="100" d="100"/>
          <a:sy n="100" d="100"/>
        </p:scale>
        <p:origin x="137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41A3A-27AF-1945-80D4-CC99CC6EA5FC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3514E-C805-E642-9C58-A1FD18B83A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665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41A3A-27AF-1945-80D4-CC99CC6EA5FC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3514E-C805-E642-9C58-A1FD18B83A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542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41A3A-27AF-1945-80D4-CC99CC6EA5FC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3514E-C805-E642-9C58-A1FD18B83A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178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41A3A-27AF-1945-80D4-CC99CC6EA5FC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3514E-C805-E642-9C58-A1FD18B83A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730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3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7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/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41A3A-27AF-1945-80D4-CC99CC6EA5FC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3514E-C805-E642-9C58-A1FD18B83A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9239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41A3A-27AF-1945-80D4-CC99CC6EA5FC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3514E-C805-E642-9C58-A1FD18B83A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3590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1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1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41A3A-27AF-1945-80D4-CC99CC6EA5FC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3514E-C805-E642-9C58-A1FD18B83A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137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41A3A-27AF-1945-80D4-CC99CC6EA5FC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3514E-C805-E642-9C58-A1FD18B83A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3574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41A3A-27AF-1945-80D4-CC99CC6EA5FC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3514E-C805-E642-9C58-A1FD18B83A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23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69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41A3A-27AF-1945-80D4-CC99CC6EA5FC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3514E-C805-E642-9C58-A1FD18B83A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761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69"/>
            <a:ext cx="3471863" cy="6498167"/>
          </a:xfrm>
        </p:spPr>
        <p:txBody>
          <a:bodyPr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E41A3A-27AF-1945-80D4-CC99CC6EA5FC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B3514E-C805-E642-9C58-A1FD18B83A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288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E41A3A-27AF-1945-80D4-CC99CC6EA5FC}" type="datetimeFigureOut">
              <a:rPr lang="en-US" smtClean="0"/>
              <a:t>6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B3514E-C805-E642-9C58-A1FD18B83A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996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emf"/><Relationship Id="rId7" Type="http://schemas.openxmlformats.org/officeDocument/2006/relationships/image" Target="../media/image6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10" Type="http://schemas.openxmlformats.org/officeDocument/2006/relationships/image" Target="../media/image9.png"/><Relationship Id="rId4" Type="http://schemas.openxmlformats.org/officeDocument/2006/relationships/image" Target="../media/image3.emf"/><Relationship Id="rId9" Type="http://schemas.openxmlformats.org/officeDocument/2006/relationships/image" Target="../media/image8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emf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emf"/><Relationship Id="rId4" Type="http://schemas.openxmlformats.org/officeDocument/2006/relationships/image" Target="../media/image12.emf"/><Relationship Id="rId9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0ECBEE9-737A-4B69-8FAC-9F70D3CDD5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23500" y="1863932"/>
            <a:ext cx="1427868" cy="1576218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E203CF4F-D68B-448C-98B8-178DEFE091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7000" y="3463859"/>
            <a:ext cx="2834651" cy="1044796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4D5C0061-4124-4C05-9F90-FAC5CA21FB2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849" y="1896560"/>
            <a:ext cx="3835850" cy="141679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DE060C3-6CC6-5749-8906-1C222B6B9322}"/>
              </a:ext>
            </a:extLst>
          </p:cNvPr>
          <p:cNvSpPr txBox="1"/>
          <p:nvPr/>
        </p:nvSpPr>
        <p:spPr>
          <a:xfrm>
            <a:off x="0" y="14977"/>
            <a:ext cx="1582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59122BE-34A0-2044-88C1-387649A5D43E}"/>
              </a:ext>
            </a:extLst>
          </p:cNvPr>
          <p:cNvSpPr txBox="1"/>
          <p:nvPr/>
        </p:nvSpPr>
        <p:spPr>
          <a:xfrm>
            <a:off x="-9497" y="33842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2497E47-1417-1643-9FA7-EF91FB9FA3AF}"/>
              </a:ext>
            </a:extLst>
          </p:cNvPr>
          <p:cNvSpPr txBox="1"/>
          <p:nvPr/>
        </p:nvSpPr>
        <p:spPr>
          <a:xfrm>
            <a:off x="2995997" y="39557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A8B8424-0317-9B47-B4E2-A9A55AEC472B}"/>
              </a:ext>
            </a:extLst>
          </p:cNvPr>
          <p:cNvSpPr txBox="1"/>
          <p:nvPr/>
        </p:nvSpPr>
        <p:spPr>
          <a:xfrm>
            <a:off x="-27458" y="191493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2C89283-6556-3B44-ADE6-DBA1185281D6}"/>
              </a:ext>
            </a:extLst>
          </p:cNvPr>
          <p:cNvSpPr txBox="1"/>
          <p:nvPr/>
        </p:nvSpPr>
        <p:spPr>
          <a:xfrm>
            <a:off x="3854699" y="192755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223DB412-4DB7-4FFB-990C-C730225E721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8950" y="492569"/>
            <a:ext cx="2765845" cy="96656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1FEBD3CA-09A3-4C0E-B8BF-5AB68CCC9CB3}"/>
              </a:ext>
            </a:extLst>
          </p:cNvPr>
          <p:cNvSpPr txBox="1"/>
          <p:nvPr/>
        </p:nvSpPr>
        <p:spPr>
          <a:xfrm>
            <a:off x="3830957" y="332536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6790376-1C73-47EC-86EE-4B1C913788A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23260" y="395577"/>
            <a:ext cx="2513363" cy="1595148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7B832936-DE1D-450C-A656-6CB33DF2E17C}"/>
              </a:ext>
            </a:extLst>
          </p:cNvPr>
          <p:cNvSpPr txBox="1"/>
          <p:nvPr/>
        </p:nvSpPr>
        <p:spPr>
          <a:xfrm>
            <a:off x="153110" y="3437108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48A545B-A8D3-4F97-9ED1-DC079006BF4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01533" y="4983154"/>
            <a:ext cx="335901" cy="33590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2AA28FB-702F-4AFA-9A3D-C991B4C6C38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841845" y="4992680"/>
            <a:ext cx="335901" cy="335901"/>
          </a:xfrm>
          <a:prstGeom prst="rect">
            <a:avLst/>
          </a:prstGeom>
        </p:spPr>
      </p:pic>
      <p:pic>
        <p:nvPicPr>
          <p:cNvPr id="14" name="Picture 13" descr="A picture containing white&#10;&#10;Description automatically generated">
            <a:extLst>
              <a:ext uri="{FF2B5EF4-FFF2-40B4-BE49-F238E27FC236}">
                <a16:creationId xmlns:a16="http://schemas.microsoft.com/office/drawing/2014/main" id="{AC96F750-C634-426F-8EBA-778F907DC01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82157" y="4983154"/>
            <a:ext cx="346622" cy="34662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9CC270A6-1F8B-4CCE-BFEF-2B76E4FF6CD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047280" y="3384292"/>
            <a:ext cx="1504087" cy="16095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721057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DE060C3-6CC6-5749-8906-1C222B6B9322}"/>
              </a:ext>
            </a:extLst>
          </p:cNvPr>
          <p:cNvSpPr txBox="1"/>
          <p:nvPr/>
        </p:nvSpPr>
        <p:spPr>
          <a:xfrm>
            <a:off x="0" y="14977"/>
            <a:ext cx="1685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59122BE-34A0-2044-88C1-387649A5D43E}"/>
              </a:ext>
            </a:extLst>
          </p:cNvPr>
          <p:cNvSpPr txBox="1"/>
          <p:nvPr/>
        </p:nvSpPr>
        <p:spPr>
          <a:xfrm>
            <a:off x="-9497" y="33842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2497E47-1417-1643-9FA7-EF91FB9FA3AF}"/>
              </a:ext>
            </a:extLst>
          </p:cNvPr>
          <p:cNvSpPr txBox="1"/>
          <p:nvPr/>
        </p:nvSpPr>
        <p:spPr>
          <a:xfrm>
            <a:off x="16151" y="302137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D193F28A-5C99-0842-85EB-B88F408FD4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5395" y="3129012"/>
            <a:ext cx="2973432" cy="155357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BB89292-B830-4F41-9C6D-D9434D1ADA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5777" y="1839513"/>
            <a:ext cx="2713101" cy="1075649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AF0FDA2-3F2F-4322-B30A-A4713E862CD5}"/>
              </a:ext>
            </a:extLst>
          </p:cNvPr>
          <p:cNvSpPr txBox="1"/>
          <p:nvPr/>
        </p:nvSpPr>
        <p:spPr>
          <a:xfrm>
            <a:off x="3463293" y="338426"/>
            <a:ext cx="295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2F8CBB2A-147E-44DF-B0BC-8E406C4F7F1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8395" y="1008778"/>
            <a:ext cx="2973432" cy="7339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005B1D92-463B-4040-989C-16F44499567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00590" y="864241"/>
            <a:ext cx="1295880" cy="13608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DFECFA93-0C44-442C-863D-F063BBFD8823}"/>
              </a:ext>
            </a:extLst>
          </p:cNvPr>
          <p:cNvSpPr txBox="1"/>
          <p:nvPr/>
        </p:nvSpPr>
        <p:spPr>
          <a:xfrm>
            <a:off x="-9497" y="184435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3E2190D-7638-4187-B9F5-FCCFB8C406A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7819" y="346152"/>
            <a:ext cx="2973432" cy="63438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27F5230-508B-41DE-BAEE-C9F4C3B5A17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06304" y="441402"/>
            <a:ext cx="1930591" cy="41085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B53FCB4-4BE3-4574-9E1C-5E23FC3A449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4737" y="4896433"/>
            <a:ext cx="3184090" cy="1039158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5C36F29E-FC24-4638-8759-5D178C96EB97}"/>
              </a:ext>
            </a:extLst>
          </p:cNvPr>
          <p:cNvSpPr txBox="1"/>
          <p:nvPr/>
        </p:nvSpPr>
        <p:spPr>
          <a:xfrm>
            <a:off x="-19115" y="4757933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B1FEE09-0B26-4AD6-9C90-12348959566D}"/>
              </a:ext>
            </a:extLst>
          </p:cNvPr>
          <p:cNvSpPr txBox="1"/>
          <p:nvPr/>
        </p:nvSpPr>
        <p:spPr>
          <a:xfrm>
            <a:off x="3511591" y="2395183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192EB29-AE90-4D0D-B652-2B4B4BC645C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891090" y="2434487"/>
            <a:ext cx="1099034" cy="34136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11672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DE060C3-6CC6-5749-8906-1C222B6B9322}"/>
              </a:ext>
            </a:extLst>
          </p:cNvPr>
          <p:cNvSpPr txBox="1"/>
          <p:nvPr/>
        </p:nvSpPr>
        <p:spPr>
          <a:xfrm>
            <a:off x="0" y="14977"/>
            <a:ext cx="16850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59122BE-34A0-2044-88C1-387649A5D43E}"/>
              </a:ext>
            </a:extLst>
          </p:cNvPr>
          <p:cNvSpPr txBox="1"/>
          <p:nvPr/>
        </p:nvSpPr>
        <p:spPr>
          <a:xfrm>
            <a:off x="-9497" y="33842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2497E47-1417-1643-9FA7-EF91FB9FA3AF}"/>
              </a:ext>
            </a:extLst>
          </p:cNvPr>
          <p:cNvSpPr txBox="1"/>
          <p:nvPr/>
        </p:nvSpPr>
        <p:spPr>
          <a:xfrm>
            <a:off x="0" y="235159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C81F2C63-E022-A641-9B05-80504A0358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568" y="2435868"/>
            <a:ext cx="3026432" cy="180100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894BFBF-BB7E-4CD0-9D38-6F187C7FF3C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7096"/>
          <a:stretch/>
        </p:blipFill>
        <p:spPr>
          <a:xfrm>
            <a:off x="255665" y="471837"/>
            <a:ext cx="1839783" cy="170930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107394A-8D9D-425A-AEDE-303531A3B5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17572" y="252658"/>
            <a:ext cx="3192759" cy="2132599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7B470A2E-36A8-4965-AAD2-8885F2688533}"/>
              </a:ext>
            </a:extLst>
          </p:cNvPr>
          <p:cNvSpPr txBox="1"/>
          <p:nvPr/>
        </p:nvSpPr>
        <p:spPr>
          <a:xfrm>
            <a:off x="2055314" y="33333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tr-T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59868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2</TotalTime>
  <Words>25</Words>
  <Application>Microsoft Office PowerPoint</Application>
  <PresentationFormat>Letter Paper (8.5x11 in)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mer Onder</dc:creator>
  <cp:lastModifiedBy>Deniz Uğurlu Çimen</cp:lastModifiedBy>
  <cp:revision>43</cp:revision>
  <dcterms:created xsi:type="dcterms:W3CDTF">2020-12-02T19:08:23Z</dcterms:created>
  <dcterms:modified xsi:type="dcterms:W3CDTF">2021-06-16T19:20:12Z</dcterms:modified>
</cp:coreProperties>
</file>